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533CF-6A71-4E1E-9A85-91CFB4C721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5F020-4CCC-4258-ABB3-D4541EFF59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6C3E4-594A-489C-BF59-6AF4BD6006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E06C5-742B-4651-BD02-B33B8B6D83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F40720-A200-49C7-BBD7-C5E825CD65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DB1E8-075E-4E40-9501-E1ADA165F4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8D7C3-76E2-4052-8050-80038E201A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5F44A-A90B-49AD-AACB-8FDDE0031B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996441-19E7-4EB3-B638-5BEAF4D89B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9E599-F47D-4D38-9BAC-3FF6DF4DAA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7BBA47-096A-40D0-A05D-80D1675F71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831EA-8C14-4462-A367-06BE925023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715CFB-71B3-4183-8124-A20E4BB4D5A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4.wmf"/><Relationship Id="rId3" Type="http://schemas.openxmlformats.org/officeDocument/2006/relationships/image" Target="../media/image5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"/>
          <p:cNvSpPr/>
          <p:nvPr/>
        </p:nvSpPr>
        <p:spPr>
          <a:xfrm>
            <a:off x="2609280" y="3143160"/>
            <a:ext cx="1665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elative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R</a:t>
            </a:r>
            <a:r>
              <a:rPr b="0" i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mRNA expressio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7"/>
          <p:cNvSpPr/>
          <p:nvPr/>
        </p:nvSpPr>
        <p:spPr>
          <a:xfrm rot="16200000">
            <a:off x="1270800" y="1925640"/>
            <a:ext cx="167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elative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SHH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mRNA expressio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20"/>
          <p:cNvSpPr/>
          <p:nvPr/>
        </p:nvSpPr>
        <p:spPr>
          <a:xfrm>
            <a:off x="2574360" y="6507000"/>
            <a:ext cx="1665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elative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R</a:t>
            </a:r>
            <a:r>
              <a:rPr b="0" i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mRNA expressio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21"/>
          <p:cNvSpPr/>
          <p:nvPr/>
        </p:nvSpPr>
        <p:spPr>
          <a:xfrm rot="16200000">
            <a:off x="1213920" y="5202000"/>
            <a:ext cx="167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elative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SHH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mRNA expressio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42"/>
          <p:cNvSpPr/>
          <p:nvPr/>
        </p:nvSpPr>
        <p:spPr>
          <a:xfrm>
            <a:off x="3878280" y="1060560"/>
            <a:ext cx="135000" cy="13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44"/>
          <p:cNvSpPr/>
          <p:nvPr/>
        </p:nvSpPr>
        <p:spPr>
          <a:xfrm>
            <a:off x="860040" y="3402000"/>
            <a:ext cx="4954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ig.1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Correlation with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ER</a:t>
            </a:r>
            <a:r>
              <a:rPr b="0" i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 and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Shh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 mRNA expression in histological diffuse-type gastric cancer tissues.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45"/>
          <p:cNvSpPr/>
          <p:nvPr/>
        </p:nvSpPr>
        <p:spPr>
          <a:xfrm>
            <a:off x="859680" y="6912000"/>
            <a:ext cx="505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ig.1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Correlation with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ER</a:t>
            </a:r>
            <a:r>
              <a:rPr b="0" i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 and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Shh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明朝"/>
              </a:rPr>
              <a:t> mRNA expression in histological intestinal-type gastric cancer tissues.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1"/>
          <a:srcRect l="0" t="7817" r="0" b="0"/>
          <a:stretch/>
        </p:blipFill>
        <p:spPr>
          <a:xfrm>
            <a:off x="2195640" y="4314960"/>
            <a:ext cx="2465280" cy="219204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39"/>
          <p:cNvSpPr/>
          <p:nvPr/>
        </p:nvSpPr>
        <p:spPr>
          <a:xfrm>
            <a:off x="3878280" y="5516640"/>
            <a:ext cx="1155600" cy="28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=0.5029 (p&lt;0.0226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7"/>
          <p:cNvSpPr/>
          <p:nvPr/>
        </p:nvSpPr>
        <p:spPr>
          <a:xfrm>
            <a:off x="4042080" y="4211640"/>
            <a:ext cx="915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Intestinal (n=2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AutoShape 37"/>
          <p:cNvSpPr/>
          <p:nvPr/>
        </p:nvSpPr>
        <p:spPr>
          <a:xfrm>
            <a:off x="3949560" y="4254480"/>
            <a:ext cx="135000" cy="135000"/>
          </a:xfrm>
          <a:prstGeom prst="diamond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0880" bIns="20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2"/>
          <a:srcRect l="0" t="0" r="0" b="5182"/>
          <a:stretch/>
        </p:blipFill>
        <p:spPr>
          <a:xfrm>
            <a:off x="2141640" y="971640"/>
            <a:ext cx="2457360" cy="2205000"/>
          </a:xfrm>
          <a:prstGeom prst="rect">
            <a:avLst/>
          </a:prstGeom>
          <a:ln w="0">
            <a:noFill/>
          </a:ln>
        </p:spPr>
      </p:pic>
      <p:sp>
        <p:nvSpPr>
          <p:cNvPr id="53" name="Text Box 13"/>
          <p:cNvSpPr/>
          <p:nvPr/>
        </p:nvSpPr>
        <p:spPr>
          <a:xfrm>
            <a:off x="4059360" y="936720"/>
            <a:ext cx="1035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iffuse (n=2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2"/>
          <p:cNvSpPr/>
          <p:nvPr/>
        </p:nvSpPr>
        <p:spPr>
          <a:xfrm>
            <a:off x="3968640" y="981000"/>
            <a:ext cx="135000" cy="13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1"/>
          <p:cNvSpPr/>
          <p:nvPr/>
        </p:nvSpPr>
        <p:spPr>
          <a:xfrm>
            <a:off x="3703320" y="1916280"/>
            <a:ext cx="1146960" cy="28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=0.7286 (p&lt;0.0001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367"/>
          <p:cNvSpPr/>
          <p:nvPr/>
        </p:nvSpPr>
        <p:spPr>
          <a:xfrm>
            <a:off x="1000080" y="394164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67"/>
          <p:cNvSpPr/>
          <p:nvPr/>
        </p:nvSpPr>
        <p:spPr>
          <a:xfrm>
            <a:off x="1135080" y="56664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3"/>
          <p:cNvSpPr/>
          <p:nvPr/>
        </p:nvSpPr>
        <p:spPr>
          <a:xfrm>
            <a:off x="2259360" y="162000"/>
            <a:ext cx="229284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-Mincho"/>
              </a:rPr>
              <a:t>Supplementary Information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 Box 17"/>
          <p:cNvSpPr/>
          <p:nvPr/>
        </p:nvSpPr>
        <p:spPr>
          <a:xfrm>
            <a:off x="1883160" y="1028880"/>
            <a:ext cx="57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ATO I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0" name=""/>
          <p:cNvGraphicFramePr/>
          <p:nvPr/>
        </p:nvGraphicFramePr>
        <p:xfrm>
          <a:off x="1314360" y="2997360"/>
          <a:ext cx="1800360" cy="426960"/>
        </p:xfrm>
        <a:graphic>
          <a:graphicData uri="http://schemas.openxmlformats.org/drawingml/2006/table">
            <a:tbl>
              <a:tblPr/>
              <a:tblGrid>
                <a:gridCol w="360360"/>
                <a:gridCol w="360360"/>
                <a:gridCol w="358920"/>
                <a:gridCol w="360360"/>
                <a:gridCol w="360360"/>
              </a:tblGrid>
              <a:tr h="2156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1" name="Text Box 135"/>
          <p:cNvSpPr/>
          <p:nvPr/>
        </p:nvSpPr>
        <p:spPr>
          <a:xfrm>
            <a:off x="909720" y="66996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36"/>
          <p:cNvSpPr/>
          <p:nvPr/>
        </p:nvSpPr>
        <p:spPr>
          <a:xfrm>
            <a:off x="795240" y="2962440"/>
            <a:ext cx="51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2(n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37"/>
          <p:cNvSpPr/>
          <p:nvPr/>
        </p:nvSpPr>
        <p:spPr>
          <a:xfrm>
            <a:off x="638280" y="3176640"/>
            <a:ext cx="765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M (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4" name=""/>
          <p:cNvGraphicFramePr/>
          <p:nvPr/>
        </p:nvGraphicFramePr>
        <p:xfrm>
          <a:off x="4014720" y="2997360"/>
          <a:ext cx="1800360" cy="425160"/>
        </p:xfrm>
        <a:graphic>
          <a:graphicData uri="http://schemas.openxmlformats.org/drawingml/2006/table">
            <a:tbl>
              <a:tblPr/>
              <a:tblGrid>
                <a:gridCol w="360360"/>
                <a:gridCol w="360360"/>
                <a:gridCol w="358920"/>
                <a:gridCol w="360360"/>
                <a:gridCol w="360360"/>
              </a:tblGrid>
              <a:tr h="2156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5" name="Text Box 227"/>
          <p:cNvSpPr/>
          <p:nvPr/>
        </p:nvSpPr>
        <p:spPr>
          <a:xfrm>
            <a:off x="3495600" y="2997360"/>
            <a:ext cx="51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2(n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28"/>
          <p:cNvSpPr/>
          <p:nvPr/>
        </p:nvSpPr>
        <p:spPr>
          <a:xfrm>
            <a:off x="3338640" y="3176640"/>
            <a:ext cx="765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M (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29"/>
          <p:cNvSpPr/>
          <p:nvPr/>
        </p:nvSpPr>
        <p:spPr>
          <a:xfrm>
            <a:off x="4624920" y="1027080"/>
            <a:ext cx="57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CI-N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40"/>
          <p:cNvSpPr/>
          <p:nvPr/>
        </p:nvSpPr>
        <p:spPr>
          <a:xfrm>
            <a:off x="2011320" y="6757920"/>
            <a:ext cx="51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2(n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41"/>
          <p:cNvSpPr/>
          <p:nvPr/>
        </p:nvSpPr>
        <p:spPr>
          <a:xfrm>
            <a:off x="1854360" y="6924600"/>
            <a:ext cx="765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M (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0" name=""/>
          <p:cNvGraphicFramePr/>
          <p:nvPr/>
        </p:nvGraphicFramePr>
        <p:xfrm>
          <a:off x="2529000" y="6802560"/>
          <a:ext cx="2160000" cy="425160"/>
        </p:xfrm>
        <a:graphic>
          <a:graphicData uri="http://schemas.openxmlformats.org/drawingml/2006/table">
            <a:tbl>
              <a:tblPr/>
              <a:tblGrid>
                <a:gridCol w="358200"/>
                <a:gridCol w="361800"/>
                <a:gridCol w="382680"/>
                <a:gridCol w="337680"/>
                <a:gridCol w="358200"/>
                <a:gridCol w="361440"/>
              </a:tblGrid>
              <a:tr h="337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ja-JP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　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56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1" name="Rectangle 366"/>
          <p:cNvSpPr/>
          <p:nvPr/>
        </p:nvSpPr>
        <p:spPr>
          <a:xfrm>
            <a:off x="272880" y="3671280"/>
            <a:ext cx="6312240" cy="60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Fig. 2A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   Cell proliferation in the presence of E2 alone or in combination with Tamoxifen (TAM) in KATOIII and NCI-N87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1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M of TAM did not affect the proliferation of ER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-positive gastric cancer cells. Results are expressed as mea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± s.d.  *p &lt; 0.05;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67"/>
          <p:cNvSpPr/>
          <p:nvPr/>
        </p:nvSpPr>
        <p:spPr>
          <a:xfrm>
            <a:off x="865080" y="470700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54"/>
          <p:cNvSpPr/>
          <p:nvPr/>
        </p:nvSpPr>
        <p:spPr>
          <a:xfrm rot="16200000">
            <a:off x="165600" y="2249280"/>
            <a:ext cx="136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ll number (% of contro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54"/>
          <p:cNvSpPr/>
          <p:nvPr/>
        </p:nvSpPr>
        <p:spPr>
          <a:xfrm rot="16200000">
            <a:off x="2943720" y="2222280"/>
            <a:ext cx="136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ll number (% of contro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87"/>
          <p:cNvSpPr/>
          <p:nvPr/>
        </p:nvSpPr>
        <p:spPr>
          <a:xfrm>
            <a:off x="34920" y="7450920"/>
            <a:ext cx="6805800" cy="60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Fig. 2B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   Cell proliferation in the presence of E2 alone or in combination with Tamoxifen (TAM) in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MK-1 cells as ER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明朝"/>
              </a:rPr>
              <a:t>-negative cell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MS-Mincho"/>
              </a:rPr>
              <a:t>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 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 of TAM did not inhibit the proliferation of MK-1 cells. However, 3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 of TAM  inhibited the proliferation of MK-1 cells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ata indicate that 3 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 of TAM may be cytotoxic. Results are expressed as mean ± s.d.  *p &lt; 0.05;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54"/>
          <p:cNvSpPr/>
          <p:nvPr/>
        </p:nvSpPr>
        <p:spPr>
          <a:xfrm rot="16200000">
            <a:off x="1288800" y="5849640"/>
            <a:ext cx="136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ell number (% of contro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40"/>
          <p:cNvSpPr/>
          <p:nvPr/>
        </p:nvSpPr>
        <p:spPr>
          <a:xfrm>
            <a:off x="3317400" y="475128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K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" descr=""/>
          <p:cNvPicPr/>
          <p:nvPr/>
        </p:nvPicPr>
        <p:blipFill>
          <a:blip r:embed="rId1"/>
          <a:stretch/>
        </p:blipFill>
        <p:spPr>
          <a:xfrm>
            <a:off x="2122560" y="5067360"/>
            <a:ext cx="2611440" cy="1754280"/>
          </a:xfrm>
          <a:prstGeom prst="rect">
            <a:avLst/>
          </a:prstGeom>
          <a:ln w="0">
            <a:noFill/>
          </a:ln>
        </p:spPr>
      </p:pic>
      <p:sp>
        <p:nvSpPr>
          <p:cNvPr id="79" name="Text Box 383"/>
          <p:cNvSpPr/>
          <p:nvPr/>
        </p:nvSpPr>
        <p:spPr>
          <a:xfrm>
            <a:off x="3968640" y="5707080"/>
            <a:ext cx="290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 P丸ゴシック体M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" descr=""/>
          <p:cNvPicPr/>
          <p:nvPr/>
        </p:nvPicPr>
        <p:blipFill>
          <a:blip r:embed="rId2"/>
          <a:stretch/>
        </p:blipFill>
        <p:spPr>
          <a:xfrm>
            <a:off x="3699000" y="1646280"/>
            <a:ext cx="2160360" cy="1393920"/>
          </a:xfrm>
          <a:prstGeom prst="rect">
            <a:avLst/>
          </a:prstGeom>
          <a:ln w="0">
            <a:noFill/>
          </a:ln>
        </p:spPr>
      </p:pic>
      <p:sp>
        <p:nvSpPr>
          <p:cNvPr id="81" name="Text Box 231"/>
          <p:cNvSpPr/>
          <p:nvPr/>
        </p:nvSpPr>
        <p:spPr>
          <a:xfrm>
            <a:off x="5495760" y="1927080"/>
            <a:ext cx="27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 P丸ゴシック体M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" descr=""/>
          <p:cNvPicPr/>
          <p:nvPr/>
        </p:nvPicPr>
        <p:blipFill>
          <a:blip r:embed="rId3"/>
          <a:stretch/>
        </p:blipFill>
        <p:spPr>
          <a:xfrm>
            <a:off x="998640" y="1601640"/>
            <a:ext cx="2251080" cy="1441440"/>
          </a:xfrm>
          <a:prstGeom prst="rect">
            <a:avLst/>
          </a:prstGeom>
          <a:ln w="0">
            <a:noFill/>
          </a:ln>
        </p:spPr>
      </p:pic>
      <p:sp>
        <p:nvSpPr>
          <p:cNvPr id="83" name="Text Box 43"/>
          <p:cNvSpPr/>
          <p:nvPr/>
        </p:nvSpPr>
        <p:spPr>
          <a:xfrm>
            <a:off x="2172240" y="162000"/>
            <a:ext cx="229284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-Mincho"/>
              </a:rPr>
              <a:t>Supplementary Information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23T06:42:22Z</dcterms:created>
  <dc:creator>Chizu</dc:creator>
  <dc:description/>
  <dc:language>en-US</dc:language>
  <cp:lastModifiedBy>Chizu</cp:lastModifiedBy>
  <dcterms:modified xsi:type="dcterms:W3CDTF">2009-11-13T02:49:30Z</dcterms:modified>
  <cp:revision>517</cp:revision>
  <dc:subject/>
  <dc:title>スライド 1</dc:title>
</cp:coreProperties>
</file>